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54" d="100"/>
          <a:sy n="154" d="100"/>
        </p:scale>
        <p:origin x="-12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ca-ES" smtClean="0"/>
              <a:t>Feu clic aquí per editar l'esti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ca-ES" smtClean="0"/>
              <a:t>Feu clic aquí per editar l'estil de subtítols del patró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D1B41-A7D2-4A48-A12D-8753E8433FDE}" type="datetimeFigureOut">
              <a:rPr lang="ca-ES" smtClean="0"/>
              <a:t>03/07/2023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87ADA-7223-4A89-B28F-1118D2BAF3B4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41952633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ol i text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 smtClean="0"/>
              <a:t>Feu clic aquí per editar l'esti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a-ES" smtClean="0"/>
              <a:t>Editeu els estils de text del patró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D1B41-A7D2-4A48-A12D-8753E8433FDE}" type="datetimeFigureOut">
              <a:rPr lang="ca-ES" smtClean="0"/>
              <a:t>03/07/2023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87ADA-7223-4A89-B28F-1118D2BAF3B4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8612955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ol vertical i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ca-ES" smtClean="0"/>
              <a:t>Feu clic aquí per editar l'esti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ca-ES" smtClean="0"/>
              <a:t>Editeu els estils de text del patró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D1B41-A7D2-4A48-A12D-8753E8433FDE}" type="datetimeFigureOut">
              <a:rPr lang="ca-ES" smtClean="0"/>
              <a:t>03/07/2023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87ADA-7223-4A89-B28F-1118D2BAF3B4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0909971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ol i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 smtClean="0"/>
              <a:t>Feu clic aquí per editar l'esti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a-ES" smtClean="0"/>
              <a:t>Editeu els estils de text del patró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D1B41-A7D2-4A48-A12D-8753E8433FDE}" type="datetimeFigureOut">
              <a:rPr lang="ca-ES" smtClean="0"/>
              <a:t>03/07/2023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87ADA-7223-4A89-B28F-1118D2BAF3B4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40434956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pçalera de la sec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ca-ES" smtClean="0"/>
              <a:t>Feu clic aquí per editar l'e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a-ES" smtClean="0"/>
              <a:t>Editeu els estils de text del patró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D1B41-A7D2-4A48-A12D-8753E8433FDE}" type="datetimeFigureOut">
              <a:rPr lang="ca-ES" smtClean="0"/>
              <a:t>03/07/2023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87ADA-7223-4A89-B28F-1118D2BAF3B4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9110983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 smtClean="0"/>
              <a:t>Feu clic aquí per editar l'esti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ca-ES" smtClean="0"/>
              <a:t>Editeu els estils de text del patró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ca-ES" smtClean="0"/>
              <a:t>Editeu els estils de text del patró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D1B41-A7D2-4A48-A12D-8753E8433FDE}" type="datetimeFigureOut">
              <a:rPr lang="ca-ES" smtClean="0"/>
              <a:t>03/07/2023</a:t>
            </a:fld>
            <a:endParaRPr lang="ca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87ADA-7223-4A89-B28F-1118D2BAF3B4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8276324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ca-ES" smtClean="0"/>
              <a:t>Feu clic aquí per editar l'e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a-ES" smtClean="0"/>
              <a:t>Editeu els estils de text del patró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ca-ES" smtClean="0"/>
              <a:t>Editeu els estils de text del patró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a-ES" smtClean="0"/>
              <a:t>Editeu els estils de text del patró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ca-ES" smtClean="0"/>
              <a:t>Editeu els estils de text del patró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D1B41-A7D2-4A48-A12D-8753E8433FDE}" type="datetimeFigureOut">
              <a:rPr lang="ca-ES" smtClean="0"/>
              <a:t>03/07/2023</a:t>
            </a:fld>
            <a:endParaRPr lang="ca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87ADA-7223-4A89-B28F-1118D2BAF3B4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9750734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omés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 smtClean="0"/>
              <a:t>Feu clic aquí per editar l'esti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D1B41-A7D2-4A48-A12D-8753E8433FDE}" type="datetimeFigureOut">
              <a:rPr lang="ca-ES" smtClean="0"/>
              <a:t>03/07/2023</a:t>
            </a:fld>
            <a:endParaRPr lang="ca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87ADA-7223-4A89-B28F-1118D2BAF3B4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8345893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D1B41-A7D2-4A48-A12D-8753E8433FDE}" type="datetimeFigureOut">
              <a:rPr lang="ca-ES" smtClean="0"/>
              <a:t>03/07/2023</a:t>
            </a:fld>
            <a:endParaRPr lang="ca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87ADA-7223-4A89-B28F-1118D2BAF3B4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4252021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ingut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a-ES" smtClean="0"/>
              <a:t>Feu clic aquí per editar l'esti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a-ES" smtClean="0"/>
              <a:t>Editeu els estils de text del patró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a-ES" smtClean="0"/>
              <a:t>Editeu els estils de text del patró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D1B41-A7D2-4A48-A12D-8753E8433FDE}" type="datetimeFigureOut">
              <a:rPr lang="ca-ES" smtClean="0"/>
              <a:t>03/07/2023</a:t>
            </a:fld>
            <a:endParaRPr lang="ca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87ADA-7223-4A89-B28F-1118D2BAF3B4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4874627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tge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a-ES" smtClean="0"/>
              <a:t>Feu clic aquí per editar l'esti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ca-ES" smtClean="0"/>
              <a:t>Feu clic a la icona per afegir una imat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a-ES" smtClean="0"/>
              <a:t>Editeu els estils de text del patró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D1B41-A7D2-4A48-A12D-8753E8433FDE}" type="datetimeFigureOut">
              <a:rPr lang="ca-ES" smtClean="0"/>
              <a:t>03/07/2023</a:t>
            </a:fld>
            <a:endParaRPr lang="ca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87ADA-7223-4A89-B28F-1118D2BAF3B4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5581360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a-ES" smtClean="0"/>
              <a:t>Feu clic aquí per editar l'e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a-ES" smtClean="0"/>
              <a:t>Editeu els estils de text del patró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7D1B41-A7D2-4A48-A12D-8753E8433FDE}" type="datetimeFigureOut">
              <a:rPr lang="ca-ES" smtClean="0"/>
              <a:t>03/07/2023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D87ADA-7223-4A89-B28F-1118D2BAF3B4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2962158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tge 3" descr="Retallat de pantalla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74" r="5632"/>
          <a:stretch/>
        </p:blipFill>
        <p:spPr>
          <a:xfrm>
            <a:off x="191192" y="220659"/>
            <a:ext cx="2380221" cy="1454695"/>
          </a:xfrm>
          <a:prstGeom prst="rect">
            <a:avLst/>
          </a:prstGeom>
        </p:spPr>
      </p:pic>
      <p:pic>
        <p:nvPicPr>
          <p:cNvPr id="5" name="Imatge 4" descr="Retallat de pantalla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43" r="4968"/>
          <a:stretch/>
        </p:blipFill>
        <p:spPr>
          <a:xfrm>
            <a:off x="2571413" y="220587"/>
            <a:ext cx="2380221" cy="1449894"/>
          </a:xfrm>
          <a:prstGeom prst="rect">
            <a:avLst/>
          </a:prstGeom>
        </p:spPr>
      </p:pic>
      <p:pic>
        <p:nvPicPr>
          <p:cNvPr id="7" name="Imatge 6" descr="Retallat de pantalla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76" r="4276"/>
          <a:stretch/>
        </p:blipFill>
        <p:spPr>
          <a:xfrm>
            <a:off x="7374283" y="215786"/>
            <a:ext cx="2446166" cy="1454695"/>
          </a:xfrm>
          <a:prstGeom prst="rect">
            <a:avLst/>
          </a:prstGeom>
        </p:spPr>
      </p:pic>
      <p:pic>
        <p:nvPicPr>
          <p:cNvPr id="8" name="Imatge 7" descr="Retallat de pantalla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19" r="5259"/>
          <a:stretch/>
        </p:blipFill>
        <p:spPr>
          <a:xfrm>
            <a:off x="202286" y="1750918"/>
            <a:ext cx="2369127" cy="1448008"/>
          </a:xfrm>
          <a:prstGeom prst="rect">
            <a:avLst/>
          </a:prstGeom>
        </p:spPr>
      </p:pic>
      <p:pic>
        <p:nvPicPr>
          <p:cNvPr id="12" name="Imatge 11" descr="Retallat de pantalla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31" r="4504"/>
          <a:stretch/>
        </p:blipFill>
        <p:spPr>
          <a:xfrm>
            <a:off x="4951634" y="215858"/>
            <a:ext cx="2422649" cy="1454623"/>
          </a:xfrm>
          <a:prstGeom prst="rect">
            <a:avLst/>
          </a:prstGeom>
        </p:spPr>
      </p:pic>
      <p:pic>
        <p:nvPicPr>
          <p:cNvPr id="13" name="Imatge 12" descr="Retallat de pantalla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64" r="4168"/>
          <a:stretch/>
        </p:blipFill>
        <p:spPr>
          <a:xfrm>
            <a:off x="4959947" y="1746045"/>
            <a:ext cx="2434101" cy="1452881"/>
          </a:xfrm>
          <a:prstGeom prst="rect">
            <a:avLst/>
          </a:prstGeom>
        </p:spPr>
      </p:pic>
      <p:pic>
        <p:nvPicPr>
          <p:cNvPr id="11" name="Imatge 10" descr="Retallat de pantalla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67"/>
          <a:stretch/>
        </p:blipFill>
        <p:spPr>
          <a:xfrm>
            <a:off x="2571413" y="1750918"/>
            <a:ext cx="2426674" cy="1450636"/>
          </a:xfrm>
          <a:prstGeom prst="rect">
            <a:avLst/>
          </a:prstGeom>
        </p:spPr>
      </p:pic>
      <p:pic>
        <p:nvPicPr>
          <p:cNvPr id="14" name="Imatge 13" descr="Retallat de pantalla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96" r="4000"/>
          <a:stretch/>
        </p:blipFill>
        <p:spPr>
          <a:xfrm>
            <a:off x="7375527" y="1750919"/>
            <a:ext cx="2431610" cy="1448008"/>
          </a:xfrm>
          <a:prstGeom prst="rect">
            <a:avLst/>
          </a:prstGeom>
        </p:spPr>
      </p:pic>
      <p:pic>
        <p:nvPicPr>
          <p:cNvPr id="15" name="Imatge 14" descr="Retallat de pantalla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44" r="3832"/>
          <a:stretch/>
        </p:blipFill>
        <p:spPr>
          <a:xfrm>
            <a:off x="202286" y="3274489"/>
            <a:ext cx="2408137" cy="1424285"/>
          </a:xfrm>
          <a:prstGeom prst="rect">
            <a:avLst/>
          </a:prstGeom>
        </p:spPr>
      </p:pic>
      <p:pic>
        <p:nvPicPr>
          <p:cNvPr id="16" name="Imatge 15" descr="Retallat de pantalla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11" r="3748"/>
          <a:stretch/>
        </p:blipFill>
        <p:spPr>
          <a:xfrm>
            <a:off x="2557568" y="3269417"/>
            <a:ext cx="2415732" cy="1435603"/>
          </a:xfrm>
          <a:prstGeom prst="rect">
            <a:avLst/>
          </a:prstGeom>
        </p:spPr>
      </p:pic>
      <p:pic>
        <p:nvPicPr>
          <p:cNvPr id="17" name="Imatge 16" descr="Retallat de pantalla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08" r="3664"/>
          <a:stretch/>
        </p:blipFill>
        <p:spPr>
          <a:xfrm>
            <a:off x="4951634" y="3266789"/>
            <a:ext cx="2426956" cy="1429902"/>
          </a:xfrm>
          <a:prstGeom prst="rect">
            <a:avLst/>
          </a:prstGeom>
        </p:spPr>
      </p:pic>
      <p:pic>
        <p:nvPicPr>
          <p:cNvPr id="18" name="Imatge 17" descr="Retallat de pantalla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95" r="3498"/>
          <a:stretch/>
        </p:blipFill>
        <p:spPr>
          <a:xfrm>
            <a:off x="7361834" y="3274489"/>
            <a:ext cx="2458615" cy="1448943"/>
          </a:xfrm>
          <a:prstGeom prst="rect">
            <a:avLst/>
          </a:prstGeom>
        </p:spPr>
      </p:pic>
      <p:pic>
        <p:nvPicPr>
          <p:cNvPr id="20" name="Imatge 19" descr="Retallat de pantalla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12" r="3497"/>
          <a:stretch/>
        </p:blipFill>
        <p:spPr>
          <a:xfrm>
            <a:off x="2562458" y="4772254"/>
            <a:ext cx="2435629" cy="1440225"/>
          </a:xfrm>
          <a:prstGeom prst="rect">
            <a:avLst/>
          </a:prstGeom>
        </p:spPr>
      </p:pic>
      <p:pic>
        <p:nvPicPr>
          <p:cNvPr id="19" name="Imatge 18" descr="Retallat de pantalla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80" r="3580"/>
          <a:stretch/>
        </p:blipFill>
        <p:spPr>
          <a:xfrm>
            <a:off x="191192" y="4772884"/>
            <a:ext cx="2419231" cy="1427962"/>
          </a:xfrm>
          <a:prstGeom prst="rect">
            <a:avLst/>
          </a:prstGeom>
        </p:spPr>
      </p:pic>
      <p:sp>
        <p:nvSpPr>
          <p:cNvPr id="22" name="QuadreDeText 21"/>
          <p:cNvSpPr txBox="1"/>
          <p:nvPr/>
        </p:nvSpPr>
        <p:spPr>
          <a:xfrm>
            <a:off x="7413407" y="4761674"/>
            <a:ext cx="2352840" cy="18928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 smtClean="0"/>
              <a:t>Supplementary figure:</a:t>
            </a:r>
          </a:p>
          <a:p>
            <a:pPr algn="just"/>
            <a:r>
              <a:rPr lang="en-US" sz="900" dirty="0" smtClean="0"/>
              <a:t>Evolution of the viral load in patients after the CMVIG therapy.</a:t>
            </a:r>
          </a:p>
          <a:p>
            <a:pPr algn="just"/>
            <a:r>
              <a:rPr lang="en-US" sz="900" dirty="0" smtClean="0"/>
              <a:t>For each patient, the </a:t>
            </a:r>
            <a:r>
              <a:rPr lang="en-US" sz="900" i="1" dirty="0" smtClean="0"/>
              <a:t>x</a:t>
            </a:r>
            <a:r>
              <a:rPr lang="en-US" sz="900" dirty="0" smtClean="0"/>
              <a:t> axis shows the days since the HSCT and the </a:t>
            </a:r>
            <a:r>
              <a:rPr lang="en-US" sz="900" i="1" dirty="0" smtClean="0"/>
              <a:t>y</a:t>
            </a:r>
            <a:r>
              <a:rPr lang="en-US" sz="900" dirty="0" smtClean="0"/>
              <a:t> axis shows the logarithm of the viral load. The black arrow indicates the start of the CMVIG therapy; other treatments are also indicated. The black bars at the bottom of each graph indicate reactivations in patients with recurrent CMV. </a:t>
            </a:r>
            <a:r>
              <a:rPr lang="en-US" sz="900" i="1" dirty="0" smtClean="0"/>
              <a:t>FOS: foscarnet; GAN: ganciclovir; VAL: valganciclovir; CID: cidofovir; CTLs: CMV specific cytotoxic T lymphocytes.</a:t>
            </a:r>
            <a:endParaRPr lang="en-US" sz="900" i="1" dirty="0"/>
          </a:p>
        </p:txBody>
      </p:sp>
      <p:pic>
        <p:nvPicPr>
          <p:cNvPr id="23" name="Imatge 22" descr="Retallat de pantalla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80" r="3916"/>
          <a:stretch/>
        </p:blipFill>
        <p:spPr>
          <a:xfrm>
            <a:off x="4963263" y="4740058"/>
            <a:ext cx="2450144" cy="14724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2412157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l'Office">
  <a:themeElements>
    <a:clrScheme name="Tema de l'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l'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l'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19</TotalTime>
  <Words>98</Words>
  <Application>Microsoft Office PowerPoint</Application>
  <PresentationFormat>Paper A4 (210 x 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Tipus de lletra utilitzats</vt:lpstr>
      </vt:variant>
      <vt:variant>
        <vt:i4>3</vt:i4>
      </vt:variant>
      <vt:variant>
        <vt:lpstr>Tema</vt:lpstr>
      </vt:variant>
      <vt:variant>
        <vt:i4>1</vt:i4>
      </vt:variant>
      <vt:variant>
        <vt:lpstr>Títols de l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l'Office</vt:lpstr>
      <vt:lpstr>Presentació del PowerPoint</vt:lpstr>
    </vt:vector>
  </TitlesOfParts>
  <Company>CTT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 del PowerPoint</dc:title>
  <dc:creator>Panesso Romero, Melissa</dc:creator>
  <cp:lastModifiedBy>Panesso Romero, Melissa</cp:lastModifiedBy>
  <cp:revision>12</cp:revision>
  <dcterms:created xsi:type="dcterms:W3CDTF">2023-07-03T14:17:04Z</dcterms:created>
  <dcterms:modified xsi:type="dcterms:W3CDTF">2023-07-05T08:16:58Z</dcterms:modified>
</cp:coreProperties>
</file>